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8" r:id="rId12"/>
    <p:sldId id="267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803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96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052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8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920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280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811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8434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055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656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747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647DDE-54CA-48A9-A1E9-B60895870D27}" type="datetimeFigureOut">
              <a:rPr lang="en-US" smtClean="0"/>
              <a:t>5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E9B867-1F6A-4EC8-A3AB-7017DA935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866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the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e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tled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‘Women and Insecurity in Nigeria: The Way Forward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thor: Afolabi Comfort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misi</a:t>
            </a:r>
            <a:endParaRPr 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count Code: 0603127824PRD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60855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0"/>
            <a:ext cx="12192000" cy="71096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X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3-5/5/2020, 4 persons were killed in Messiah College High School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llage in Plateau State by bandits. They also attacked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ool head, Rev.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y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James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monur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His two childre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t and seriously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ounded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19/10/2020, 55 people  were massacred in Kaduna State by Hausa Muslims and youths during a dispute in revenge for a communal conflict that erupted betwee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ar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usa people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/12/2020, about 1,000 persons were killed in Zaria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duna State during a religious procession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rst 6 week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2022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,525 Nigerians were killed in Kaduna,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amfar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n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es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3/6/2021, 88 people were killed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ebb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by Cattle thieves who attacked seve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llages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/6/2021, 18 people were kill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tir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kot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by bandits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4/12/2021, Islamic Stat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West Africa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rrorists fired 4 rockets into Maiduguri which landed within 2.4km of the airport in the town where a civilian was killed with several casualties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/12/2021, 58 persons were murdered by bandits and Boko Haram in Kaduna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n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es. 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957247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93183" y="231820"/>
            <a:ext cx="11861442" cy="48936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MMARY OF  THE DATA</a:t>
            </a:r>
          </a:p>
          <a:p>
            <a:endParaRPr lang="en-US" sz="2400" dirty="0" smtClean="0">
              <a:solidFill>
                <a:srgbClr val="7030A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of th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ove shows that over 38,530 people were killed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of th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 that 8,585 people were massacred while over 385 wer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jured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of th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 that 4,621 persons were killed while 312 wer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jured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of th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s that 333 people were killed, 80 were injured while more than 2,000 houses were burnt down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of th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 that over 1,099 lives were lost, 1,000 houses were burnt while 400 people wer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rested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of th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s that more than 381 persons were killed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 of th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 that over 147 innocent people were massacred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 of th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s that more than 240 people wer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illed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 of th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s that more than 2,749 persons were killed.</a:t>
            </a:r>
          </a:p>
        </p:txBody>
      </p:sp>
    </p:spTree>
    <p:extLst>
      <p:ext uri="{BB962C8B-B14F-4D97-AF65-F5344CB8AC3E}">
        <p14:creationId xmlns:p14="http://schemas.microsoft.com/office/powerpoint/2010/main" val="362746541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128789"/>
            <a:ext cx="12041746" cy="60016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URCES OF THE DATA</a:t>
            </a:r>
          </a:p>
          <a:p>
            <a:endParaRPr lang="en-US" sz="2400" dirty="0" smtClean="0">
              <a:solidFill>
                <a:srgbClr val="7030A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deral Research Division of the Library of Congress (1991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fuyan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ghegb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01);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zokwe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002); Human Rights Watch (1999 a &amp; b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nimm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06); Harnischfeger (2008);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BC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ws, (2002); Human Rights Watch (2005); APF (2008); APF (2008); Guardian (2009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</a:t>
            </a: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ssiter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0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ssiter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1); Al Jazeera, 2011); Reuters (2011a); Reuters (2011b);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uter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012); Sky News (2012); Reuters, 2011b); Reuters (2012); (Sky News (2012);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ociat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s (2012); BBC News (2012); CNN (2012); Nigeria Intel (2013);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ssiter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013); McElroy (2013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ffer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3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mb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4); IANS (2014a);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AN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014b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dullah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4); IANS (2014c); Vanguard (2016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mfield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8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</a:t>
            </a: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ily Trust (2019); Borneo Post Online (2019); Daily Trust, 2019); Daily Trust (2019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</a:t>
            </a: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 Jazeera (2019) &amp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kunloy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9)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usar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9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peyem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9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adel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9);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hain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ab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9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un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9); Sahara Reporters (2019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sosany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9);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u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019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khain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ab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9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un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9); Sahara Reporters (2019);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osanya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019);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r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019); Amnesty International (2020); Deutsche (2020);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§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istia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, 2021); www.gov.uk/foreign-travel/2021; vanguardgr.com/2021.</a:t>
            </a:r>
          </a:p>
        </p:txBody>
      </p:sp>
    </p:spTree>
    <p:extLst>
      <p:ext uri="{BB962C8B-B14F-4D97-AF65-F5344CB8AC3E}">
        <p14:creationId xmlns:p14="http://schemas.microsoft.com/office/powerpoint/2010/main" val="28676417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0"/>
            <a:ext cx="11991109" cy="79119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IDENTS OF INSECURITY IN NIGERIA</a:t>
            </a:r>
          </a:p>
          <a:p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I</a:t>
            </a:r>
          </a:p>
          <a:p>
            <a:endParaRPr lang="en-US" sz="2400" dirty="0" smtClean="0">
              <a:solidFill>
                <a:srgbClr val="7030A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1950-1964, several people were killed during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iv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iots in Benue State for stat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eation. 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 July to August, 1966, killing of about 30,000 Igbo people during the anti-Igbo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grammes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Northern Nigeria for revenge against them for the January 15</a:t>
            </a:r>
            <a:r>
              <a:rPr lang="en-US" sz="2400" baseline="300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1966 coup. 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967, about 500 men were killed at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aba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Delta State during Biafra Civil War. 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1975, 65 people were killed in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geb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fter soldiers accused people of murdering one of them. 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1980, 380 people were massacred in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kolori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Zamfara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ate during disputes over building of a dam in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kolori</a:t>
            </a:r>
            <a:r>
              <a:rPr lang="en-US" sz="24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1990, 85 persons were killed in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muechem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Rivers State during a youth protest at Shell’s office  asking for improved infrastructure and payment for degradation of their environment.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1999, 2,500 people were killed at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di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yesa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ate during conflicts in the Niger Delta.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rom February – May, 2000, about 5,000 people were killed during religious riots for the introduction of sharia law in Kaduna State. 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</a:p>
          <a:p>
            <a:pPr lvl="0" algn="ctr">
              <a:lnSpc>
                <a:spcPct val="115000"/>
              </a:lnSpc>
              <a:spcAft>
                <a:spcPts val="1000"/>
              </a:spcAft>
            </a:pP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100" dirty="0">
              <a:solidFill>
                <a:prstClr val="black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dirty="0" smtClean="0"/>
              <a:t> 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endParaRPr lang="en-US" dirty="0"/>
          </a:p>
          <a:p>
            <a:pPr marL="285750" indent="-285750">
              <a:buFont typeface="Wingdings" panose="05000000000000000000" pitchFamily="2" charset="2"/>
              <a:buChar char="Ø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04549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90945" y="0"/>
            <a:ext cx="11533910" cy="52629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PHASE II</a:t>
            </a:r>
          </a:p>
          <a:p>
            <a:endParaRPr lang="en-US" sz="2400" dirty="0" smtClean="0">
              <a:solidFill>
                <a:srgbClr val="7030A0"/>
              </a:solidFill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year 2000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200 people were killed in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Zaki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iam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n Benue State during 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ttack by the Nigerian Army 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while avenging 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kidnapping and murder of 19 of their colleagues  by suspected </a:t>
            </a:r>
            <a:r>
              <a:rPr lang="en-US" sz="24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iv</a:t>
            </a:r>
            <a:r>
              <a:rPr lang="en-US" sz="24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militia. 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In 2001, about 5,000 people were massacred at Jos in Plateau State during religious riots between Christians and Muslims.</a:t>
            </a: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In year 2004, 975 people were killed at </a:t>
            </a:r>
            <a:r>
              <a:rPr lang="en-US" sz="2400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Yelwa</a:t>
            </a: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z="2400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Shendam</a:t>
            </a: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and Kano towns. 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In 2006, more than 50 people were massacred at Maiduguri during Mohammed cartoons crisis. 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On 26/2/2008, over 50 people were killed in </a:t>
            </a:r>
            <a:r>
              <a:rPr lang="en-US" sz="24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Ogaminana</a:t>
            </a:r>
            <a:r>
              <a:rPr lang="en-US" sz="2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in </a:t>
            </a:r>
            <a:r>
              <a:rPr lang="en-US" sz="24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Kogi</a:t>
            </a:r>
            <a:r>
              <a:rPr lang="en-US" sz="2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State by the </a:t>
            </a: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police. 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In 2008, 318 elderly men, women and children  were murdered  in Jos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In </a:t>
            </a: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year 2009</a:t>
            </a: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, over 1,000 people were killed in Jos by Boko Haram. 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In 2010, 992 </a:t>
            </a: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people, mainly </a:t>
            </a:r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Christians were killed in Jos  by Muslims during rioting.  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3458214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83335" y="231820"/>
            <a:ext cx="11797048" cy="67403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PHASE III</a:t>
            </a:r>
          </a:p>
          <a:p>
            <a:endParaRPr lang="en-US" sz="2400" dirty="0" smtClean="0">
              <a:solidFill>
                <a:srgbClr val="7030A0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n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ugust 2011, 116 people were massacred and 312 </a:t>
            </a: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eople were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njured in </a:t>
            </a: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buja when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Boko </a:t>
            </a: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Haram bombed a United Nations’ compound.</a:t>
            </a:r>
            <a:endParaRPr lang="en-US" sz="2400" dirty="0" smtClean="0">
              <a:solidFill>
                <a:prstClr val="black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n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ovember, 2011, 150 people were killed in </a:t>
            </a:r>
            <a:r>
              <a:rPr lang="en-US" sz="24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amaturu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during Islamic militants and Boko Haram </a:t>
            </a: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attacks on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olice stations, churches, and banks. </a:t>
            </a:r>
            <a:endParaRPr lang="en-US" sz="2400" dirty="0" smtClean="0">
              <a:solidFill>
                <a:prstClr val="black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In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ecember,  2011, more than 68 </a:t>
            </a: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people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were killed in Maiduguri and </a:t>
            </a:r>
            <a:r>
              <a:rPr lang="en-US" sz="24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amaturu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when </a:t>
            </a: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Boko Haram clashed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with security men. </a:t>
            </a:r>
            <a:endParaRPr lang="en-US" sz="2400" dirty="0" smtClean="0">
              <a:solidFill>
                <a:prstClr val="black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n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5/1/2012, more than 37 persons were killed at </a:t>
            </a:r>
            <a:r>
              <a:rPr lang="en-US" sz="24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Mubi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z="24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Yola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sz="24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Gombi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and Maiduguri during  the attack of churches and  shops by Boko Haram. </a:t>
            </a:r>
            <a:endParaRPr lang="en-US" sz="2400" dirty="0" smtClean="0">
              <a:solidFill>
                <a:prstClr val="black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n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20/1/2012, 185 victims were killed in Kano </a:t>
            </a: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uring  attacks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n offices,  police stations and barracks by Boko </a:t>
            </a: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Haram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endParaRPr lang="en-US" sz="2400" dirty="0" smtClean="0">
              <a:solidFill>
                <a:prstClr val="black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n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25/12/2012, 27  persons were killed at Abuja  during Islamic militants’ attack on a church on Christmas Day and the church was set on fire. </a:t>
            </a:r>
            <a:endParaRPr lang="en-US" sz="2400" dirty="0" smtClean="0">
              <a:solidFill>
                <a:prstClr val="black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n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20/2/2012, more than 2,000 victims were killed in Kano State. </a:t>
            </a:r>
            <a:endParaRPr lang="en-US" sz="2400" dirty="0" smtClean="0">
              <a:solidFill>
                <a:prstClr val="black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On </a:t>
            </a:r>
            <a:r>
              <a:rPr lang="en-US" sz="24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8/4/2012, 38 people were killed in Kaduna  on Easter day  when Islamic terrorists bombed a </a:t>
            </a:r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church.    </a:t>
            </a:r>
            <a:endParaRPr lang="en-US" sz="2400" dirty="0">
              <a:solidFill>
                <a:prstClr val="black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r>
              <a:rPr lang="en-US" sz="2400" dirty="0" smtClean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7516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70456" y="154546"/>
            <a:ext cx="11732653" cy="63709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IV</a:t>
            </a:r>
          </a:p>
          <a:p>
            <a:endParaRPr lang="en-US" sz="2400" dirty="0" smtClean="0">
              <a:solidFill>
                <a:srgbClr val="7030A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7/8/2012, about 19 persons were killed in Kaduna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usas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bon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rr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uring Islamic terrorists bombing of thre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urches. Eighty (80)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sons wer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so injured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/8/2012, 19 people were kill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ken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en Islamic militants attacked a Deeper Life Church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19-20/4/2013, 27 people were killed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g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n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by Nigerian military and th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ko Haram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rrorist group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/7/2013, 41 students and a teacher were kill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mud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overnment Secondary School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ob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by Suspected Boko Haram terrorists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/9/2013, 44 students and teachers were killed at a College of Agriculture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ujb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ob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/1/2014, 85 persons were killed at a  mosque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wur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ndug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al Government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n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during an attack by Boko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ram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/2/2014, 39 people were killed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ndug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Bornu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unmen. </a:t>
            </a:r>
          </a:p>
          <a:p>
            <a:pPr marL="342900" indent="-342900">
              <a:buFont typeface="Wingdings" panose="05000000000000000000" pitchFamily="2" charset="2"/>
              <a:buChar char="v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25/2/2014, 59 students were killed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lamist gunmen at Federal Government College,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un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d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ob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e.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0630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0152" y="128789"/>
            <a:ext cx="11732654" cy="67403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</a:p>
          <a:p>
            <a:endParaRPr lang="en-US" sz="2400" dirty="0">
              <a:solidFill>
                <a:srgbClr val="7030A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/4/2014, 71 people were killed at Abuja when two bombs exploded in a crowded bus station in the outskirts of the town, more than 1, 000 houses wer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urnt.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6/5/2014, more than 300 persons were massacred at </a:t>
            </a: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mboru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n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when Militants attacked at night and burnt houses.  People who  tried to escape, were shot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ad.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2/6/2014, about 300 people were killed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woz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n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when Boko Haram attacked Christian villagers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6-23/6/2014, 200 persons were killed in Kano State School of Hygiene by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litant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ko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ram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-7/7/2014,  34 people were killed at Zaria in Kaduna State  by unknown gunmen during Zaria Qud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.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/12/2014, more than 1,000 homes were burnt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wur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ndug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al Government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n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during an attack by Boko Haram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-7/1/2015, about 100 people were killed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g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Bornu State by unknown gun men. Over 2, 000 people were unaccounted for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/8/2015-9/2/2016, over 80 Biafra agitators were killed, 400 were arrested, detained or imprisoned by the Nigerian security operatives at Onitsha and Aba i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bo-land.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84782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0152" y="0"/>
            <a:ext cx="12101848" cy="71096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</a:t>
            </a:r>
          </a:p>
          <a:p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v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25/6/2018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86 people were killed i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teau Stat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ing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ots between Muslim herders and Christian farmers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/2/ 2019, 26 people were kill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amfar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by herders in revenge for the death of seven herders during the preceding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ek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10-11/2/2019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141 people were kill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jur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Kaduna State during a communal violenc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ound 2019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ection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/2/2019, 17 persons were massacr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bet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at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Kaduna State by Fulani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dsmen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/2/2019, 40 people were massacr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rama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jur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Kaduna State by Fulani herdsmen in retaliation for an earlier attacks on them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/2019, 20 persons were kill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ss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g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by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burr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zum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litia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 attack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/3/2019,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 farmer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killed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wer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 in Benue State by Fulani herdsmen. The herdsmen took over the natives’ lands for grazing after the killing. 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v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/3/2019, about 35 people were massacr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ungwan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d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jur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Kaduna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te.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v"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v"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94900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0152" y="90152"/>
            <a:ext cx="12101848" cy="74789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S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I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/3/2019, 17 residents were kill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rnin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war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Kaduna State by insurgents who ambushed the people and also stole their cattle.</a:t>
            </a:r>
            <a:r>
              <a:rPr lang="en-US" dirty="0"/>
              <a:t> </a:t>
            </a:r>
            <a:endParaRPr lang="en-US" dirty="0" smtClean="0"/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/3/2019, about 52 peopl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massacr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jur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Kaduna State by Fulani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dsmen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16/3/2019, 10 persons wer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ill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du-Gbok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ng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GA in Kaduna State by herdsmen in revenge for an earlier attack when 11 cows and 28 sheep wer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aughtered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18/3/2019, several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badum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ople were  kill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at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Benue State by Militia hired by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gb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ogb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logb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ople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19//3/2019, about 10 people were kill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um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Benue State by Fulani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dsmen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19/3/2019, 5 people were kill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han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Rivers State by Iceland group as retaliation for the killing of their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mbers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26/3/2019, about 30 residents wer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ssacr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d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Jos North in Plateau State during Inter-communal violenc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at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curred between Christian and Muslim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ouths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12/5/2019, 23 people were killed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ur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mod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GA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amfar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during attack by bandits o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ng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baj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llages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eath of their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y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4779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8789" y="103031"/>
            <a:ext cx="12063211" cy="77559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SE VIII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-9/6/2019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25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son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massacr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bah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kot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by bandits during th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ght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/6/2019,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 people were kill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tir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kot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by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ndits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9/6/2019, 16 persons were killed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amfar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by bandits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nom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munity of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GA during celebration of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id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-</a:t>
            </a: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tr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14/6/2019, 34 residents were killed at </a:t>
            </a:r>
            <a:r>
              <a:rPr lang="en-US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inkafi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amfar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ing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ndit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tack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ngar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fau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dan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wa in 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nkaf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GA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2020, 76 farmers were massacred on their farms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re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iduguri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n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by Boko Haram  for assisting the Nigeria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my. 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/2/20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more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n 12 people died and several were injured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kki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ll Gate, Lagos when Nigerian army were said to have opened fire on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sters.</a:t>
            </a: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12/4/2020, 12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istians,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ding a new bride and groom were massacred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Fulani herdsman at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gin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bat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roro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unty.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18/4/2020, 47 people were massacred in </a:t>
            </a:r>
            <a:r>
              <a:rPr lang="en-US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tsina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e during Mass murders and robberies in three </a:t>
            </a:r>
            <a:r>
              <a:rPr lang="en-US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cations.</a:t>
            </a:r>
          </a:p>
          <a:p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>
              <a:buFont typeface="Wingdings" panose="05000000000000000000" pitchFamily="2" charset="2"/>
              <a:buChar char="Ø"/>
            </a:pPr>
            <a:endParaRPr lang="en-US" sz="2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 smtClean="0"/>
              <a:t>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87264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8</TotalTime>
  <Words>1973</Words>
  <Application>Microsoft Office PowerPoint</Application>
  <PresentationFormat>Widescreen</PresentationFormat>
  <Paragraphs>130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Wingdings</vt:lpstr>
      <vt:lpstr>Office Theme</vt:lpstr>
      <vt:lpstr>Data on the Paper Titled ‘Women and Insecurity in Nigeria: The Way Forward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ata on ‘Women and Insecurity in Nigeria: The Way Forward</dc:title>
  <dc:creator>Dr. Mrs Afolabi</dc:creator>
  <cp:lastModifiedBy>Dr. Mrs Afolabi</cp:lastModifiedBy>
  <cp:revision>106</cp:revision>
  <dcterms:created xsi:type="dcterms:W3CDTF">2022-05-14T07:30:52Z</dcterms:created>
  <dcterms:modified xsi:type="dcterms:W3CDTF">2022-05-14T13:13:48Z</dcterms:modified>
</cp:coreProperties>
</file>